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1910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1150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1400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9692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502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4154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324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7655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5355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1122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3502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20501-09E9-4D87-9ECA-95EAE2F9C702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4E43C-12D5-4997-AD44-B04123CB661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1861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9241" y="2075570"/>
            <a:ext cx="4596782" cy="270685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445561" y="5072718"/>
            <a:ext cx="930087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1</a:t>
            </a:r>
            <a:r>
              <a:rPr lang="zh-CN" altLang="en-US" dirty="0"/>
              <a:t>：</a:t>
            </a:r>
            <a:r>
              <a:rPr lang="en-US" dirty="0"/>
              <a:t>Frequency-sweep test of </a:t>
            </a:r>
            <a:r>
              <a:rPr lang="en-US" dirty="0" err="1"/>
              <a:t>levans</a:t>
            </a:r>
            <a:r>
              <a:rPr lang="en-US" dirty="0"/>
              <a:t> produced at pH 5.0 (white) and pH 4.0 (grey). Data were recorded at 20 °C applying a specific concentration of 5% (</a:t>
            </a:r>
            <a:r>
              <a:rPr lang="en-US" i="1" dirty="0"/>
              <a:t>w/v</a:t>
            </a:r>
            <a:r>
              <a:rPr lang="en-US" dirty="0"/>
              <a:t>) (pH 5.0) and 15% (</a:t>
            </a:r>
            <a:r>
              <a:rPr lang="en-US" i="1" dirty="0"/>
              <a:t>w/v</a:t>
            </a:r>
            <a:r>
              <a:rPr lang="en-US" dirty="0"/>
              <a:t>) (pH 4.0). G’: square, G’’: triangles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3299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k</dc:creator>
  <cp:lastModifiedBy>MDPI</cp:lastModifiedBy>
  <cp:revision>2</cp:revision>
  <dcterms:created xsi:type="dcterms:W3CDTF">2020-01-16T13:48:47Z</dcterms:created>
  <dcterms:modified xsi:type="dcterms:W3CDTF">2020-02-14T02:10:28Z</dcterms:modified>
</cp:coreProperties>
</file>